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62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1292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4CCEB6-B101-42D6-AA14-5889A476F0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9021D6-3FEE-4AA1-ACD4-2592FA5747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BC869E-6439-4B95-971E-08A0F8006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3E87EF-0317-4734-8169-8F02D57C63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3C7249-8A65-4887-8CEC-1AE20C6080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23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9A941C-77BD-463F-B138-622A78BFBE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45F6D1-1E9D-4C7C-AF91-D228326A5D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3A022E-1443-4B9E-BDF3-07FF47213F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27B901-6B1A-4878-8039-04AB23C5E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C8BE28-4A59-4665-8C36-0691DB9BE7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701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DA1D671-1406-433A-8810-ED4778BD65B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6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79FB6AA-DE01-4AC2-90F3-D23EC279D6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1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05DBEE-99D6-4567-870F-156B03C9B5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F60DAC-CD66-4E2B-9F30-F12CF603B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0EDD6F-8F0F-4D4C-9C35-D49FC9FEB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31081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DE35AC-B878-4B58-87D2-FE2913AB15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B3F5AD-0AA3-4804-90A7-96FE3C5F23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6566C6-77E6-4D5F-8ADD-EF5960F799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E1AB55-1053-4F13-8942-A4D2098495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999F24-6DB3-4CAD-96C8-1605461B1A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00333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93631A-2C9B-4DC9-AB1F-553282DC3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41"/>
            <a:ext cx="7886700" cy="2852737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040151-9789-419F-AF25-19FA396FE2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6"/>
            <a:ext cx="7886700" cy="150018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9ED2FE-6FFF-4D2F-A4CB-0AD2E0CD86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AB9B5C-5DE4-475F-AD3C-5712D890DD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BC12CD-DB7C-4201-8A78-9FC7A71966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61652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A2E8EC-93E5-471A-A411-CDB2FDD25D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A3D7A8-6F96-4199-A218-46D291B893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8D2094-0FA0-4F72-9DB0-B37A6CD1D5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38618F-3830-4FFF-AE50-D92E851A99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CE146C-CDF3-43BB-902F-B0394A5A23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CE579B-8E36-42E4-AAAB-8E0B58D2F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0523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66B271-E7A8-4A9E-8580-C3BF08FCA4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8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2A9DC9-FBC5-47FF-8AB7-BF826C82A3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3974E5-60A3-44EF-801C-3F8942A02B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9B1D51-8401-4F89-831D-DCFF1BFDB5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1" y="1681163"/>
            <a:ext cx="3887391" cy="82391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DDB4CB3-95C3-4DD2-837C-FF55351C5B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C8C7566-B4C9-475D-8F99-01BEABDF3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E358CC-A388-435D-A083-3D6F533703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A3E7C51-996E-4A93-9788-D8D7719BA1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94302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DC0149-A6E5-4EC3-9131-4DAC01AC27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A2CA2E-4087-4F80-ACF6-5EB9B32D9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F67216F-09A7-4A8F-9EBA-72B2DA93E4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969AA-AC28-48E9-BDEE-509F65F9E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29560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D04223F-3D97-48DF-AA2D-A2AE9A8A6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75A68E9-00B9-46AA-9E84-FB028B6AB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679E93-DDE7-4091-9345-833D2933C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39789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079618-F862-4CC0-ADDB-448D7D1A1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ADB4AB-271D-4F0D-B1A3-7A6D1DC5767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B7AEBF-E074-4672-900A-B82219FC33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D54FC2-B51B-40D5-9B84-F76AE92EB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BB546B-1D1A-47A4-A602-D10617AF0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F0584C-6EB2-47B6-AB61-117BDF19A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482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D0A5F7-FC8D-46D6-ACBE-B174261E58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5101CE4-7974-4FA4-95FF-6A376EA253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8"/>
            <a:ext cx="4629150" cy="4873625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BC0BED-35F8-40C5-B8EA-CF465636AE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100D1D-1201-4037-A258-5859AB0EF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6EBD25-CE80-46F7-817D-9003958835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81A877-39E1-4264-B450-53DC0D8BB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22476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D6FC384-0F10-4AAA-B059-B4BFF0F435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8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F5C7AD-8811-4B4F-9D46-6AF3601BC4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17AEB5-C7E6-427A-B42F-6B84C374E3D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82CC4A-DFF4-4099-8B8C-0230D015A9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3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838A4A-6A1C-4788-A47C-715F0365C5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2416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emf"/><Relationship Id="rId3" Type="http://schemas.openxmlformats.org/officeDocument/2006/relationships/image" Target="../media/image3.jpeg"/><Relationship Id="rId7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6.jpeg"/><Relationship Id="rId11" Type="http://schemas.openxmlformats.org/officeDocument/2006/relationships/image" Target="../media/image7.png"/><Relationship Id="rId5" Type="http://schemas.openxmlformats.org/officeDocument/2006/relationships/image" Target="../media/image5.jpeg"/><Relationship Id="rId10" Type="http://schemas.openxmlformats.org/officeDocument/2006/relationships/image" Target="../media/image2.emf"/><Relationship Id="rId4" Type="http://schemas.openxmlformats.org/officeDocument/2006/relationships/image" Target="../media/image4.jpeg"/><Relationship Id="rId9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Group 19">
            <a:extLst>
              <a:ext uri="{FF2B5EF4-FFF2-40B4-BE49-F238E27FC236}">
                <a16:creationId xmlns:a16="http://schemas.microsoft.com/office/drawing/2014/main" id="{05DAE2B8-C945-425C-A23F-4C03C62BB632}"/>
              </a:ext>
            </a:extLst>
          </p:cNvPr>
          <p:cNvGrpSpPr/>
          <p:nvPr/>
        </p:nvGrpSpPr>
        <p:grpSpPr>
          <a:xfrm>
            <a:off x="1033414" y="913842"/>
            <a:ext cx="6503336" cy="5104191"/>
            <a:chOff x="1033414" y="913842"/>
            <a:chExt cx="6503336" cy="5104191"/>
          </a:xfrm>
        </p:grpSpPr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6875A93F-6845-4171-B9D3-6B8624A979E8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1246214" y="979601"/>
              <a:ext cx="1535017" cy="1988820"/>
              <a:chOff x="82336" y="1867704"/>
              <a:chExt cx="2328527" cy="3016919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CEF944DA-B62E-42BA-B26B-B2DEA80A22D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2336" y="1867704"/>
                <a:ext cx="2194560" cy="3016919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279F3953-6EF5-4397-875E-2E182FE6A59C}"/>
                  </a:ext>
                </a:extLst>
              </p:cNvPr>
              <p:cNvSpPr txBox="1"/>
              <p:nvPr/>
            </p:nvSpPr>
            <p:spPr>
              <a:xfrm>
                <a:off x="788459" y="2475205"/>
                <a:ext cx="1622404" cy="66530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RAS G12D-NE</a:t>
                </a:r>
              </a:p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(preincubated with </a:t>
                </a:r>
              </a:p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MSO)</a:t>
                </a:r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02F16272-3730-47C7-A99E-33778F504364}"/>
                  </a:ext>
                </a:extLst>
              </p:cNvPr>
              <p:cNvSpPr txBox="1"/>
              <p:nvPr/>
            </p:nvSpPr>
            <p:spPr>
              <a:xfrm>
                <a:off x="1186373" y="4165433"/>
                <a:ext cx="1109322" cy="49022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RB-456</a:t>
                </a:r>
              </a:p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1C17F1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D = 285nM</a:t>
                </a: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369327A6-1BF5-4838-96A8-06D0ED9255D1}"/>
                </a:ext>
              </a:extLst>
            </p:cNvPr>
            <p:cNvGrpSpPr>
              <a:grpSpLocks/>
            </p:cNvGrpSpPr>
            <p:nvPr/>
          </p:nvGrpSpPr>
          <p:grpSpPr>
            <a:xfrm>
              <a:off x="2785770" y="972530"/>
              <a:ext cx="1534683" cy="1988820"/>
              <a:chOff x="2408488" y="1868083"/>
              <a:chExt cx="2273353" cy="3017520"/>
            </a:xfrm>
          </p:grpSpPr>
          <p:pic>
            <p:nvPicPr>
              <p:cNvPr id="6" name="Picture 5">
                <a:extLst>
                  <a:ext uri="{FF2B5EF4-FFF2-40B4-BE49-F238E27FC236}">
                    <a16:creationId xmlns:a16="http://schemas.microsoft.com/office/drawing/2014/main" id="{16A98082-D9B6-423E-B035-B308BD8CE611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2408488" y="1868083"/>
                <a:ext cx="2194560" cy="301752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7" name="TextBox 12">
                <a:extLst>
                  <a:ext uri="{FF2B5EF4-FFF2-40B4-BE49-F238E27FC236}">
                    <a16:creationId xmlns:a16="http://schemas.microsoft.com/office/drawing/2014/main" id="{22B19EE1-6772-4F6F-981B-2E109A1D92DC}"/>
                  </a:ext>
                </a:extLst>
              </p:cNvPr>
              <p:cNvSpPr txBox="1"/>
              <p:nvPr/>
            </p:nvSpPr>
            <p:spPr>
              <a:xfrm>
                <a:off x="3097535" y="2461965"/>
                <a:ext cx="1584306" cy="6654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RAS G12D-NE</a:t>
                </a:r>
              </a:p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(preincubated with </a:t>
                </a:r>
              </a:p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500nM BI-2852)</a:t>
                </a:r>
              </a:p>
            </p:txBody>
          </p:sp>
          <p:sp>
            <p:nvSpPr>
              <p:cNvPr id="8" name="TextBox 13">
                <a:extLst>
                  <a:ext uri="{FF2B5EF4-FFF2-40B4-BE49-F238E27FC236}">
                    <a16:creationId xmlns:a16="http://schemas.microsoft.com/office/drawing/2014/main" id="{CC3454FA-E297-4ED7-A951-A1C4F88FA55C}"/>
                  </a:ext>
                </a:extLst>
              </p:cNvPr>
              <p:cNvSpPr txBox="1"/>
              <p:nvPr/>
            </p:nvSpPr>
            <p:spPr>
              <a:xfrm>
                <a:off x="3514481" y="4166619"/>
                <a:ext cx="1083273" cy="4903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RB-456</a:t>
                </a:r>
              </a:p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1C17F1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D = 426nM</a:t>
                </a:r>
              </a:p>
            </p:txBody>
          </p:sp>
        </p:grpSp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509F0B2D-888F-4346-AA62-F12B836B18F1}"/>
                </a:ext>
              </a:extLst>
            </p:cNvPr>
            <p:cNvGrpSpPr>
              <a:grpSpLocks/>
            </p:cNvGrpSpPr>
            <p:nvPr/>
          </p:nvGrpSpPr>
          <p:grpSpPr>
            <a:xfrm>
              <a:off x="4403530" y="979601"/>
              <a:ext cx="1525899" cy="1988820"/>
              <a:chOff x="4732998" y="1867704"/>
              <a:chExt cx="2239852" cy="3017520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A2CBB90A-CB70-4870-991F-4E3AC1595CCF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732998" y="1867704"/>
                <a:ext cx="2194560" cy="301752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10" name="TextBox 16">
                <a:extLst>
                  <a:ext uri="{FF2B5EF4-FFF2-40B4-BE49-F238E27FC236}">
                    <a16:creationId xmlns:a16="http://schemas.microsoft.com/office/drawing/2014/main" id="{2D55440F-D53F-49B1-8D86-E6DE42B5A8EA}"/>
                  </a:ext>
                </a:extLst>
              </p:cNvPr>
              <p:cNvSpPr txBox="1"/>
              <p:nvPr/>
            </p:nvSpPr>
            <p:spPr>
              <a:xfrm>
                <a:off x="5402905" y="2475326"/>
                <a:ext cx="1569945" cy="66543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RAS G12D-NE</a:t>
                </a:r>
              </a:p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(preincubated with </a:t>
                </a:r>
              </a:p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750nM BI-2852)</a:t>
                </a:r>
              </a:p>
            </p:txBody>
          </p:sp>
          <p:sp>
            <p:nvSpPr>
              <p:cNvPr id="11" name="TextBox 17">
                <a:extLst>
                  <a:ext uri="{FF2B5EF4-FFF2-40B4-BE49-F238E27FC236}">
                    <a16:creationId xmlns:a16="http://schemas.microsoft.com/office/drawing/2014/main" id="{DBF4F29B-0719-4C69-9328-76A2FB9CF413}"/>
                  </a:ext>
                </a:extLst>
              </p:cNvPr>
              <p:cNvSpPr txBox="1"/>
              <p:nvPr/>
            </p:nvSpPr>
            <p:spPr>
              <a:xfrm>
                <a:off x="5874043" y="4165431"/>
                <a:ext cx="1073453" cy="4903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RB-456</a:t>
                </a:r>
              </a:p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1C17F1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D = 692nM</a:t>
                </a:r>
              </a:p>
            </p:txBody>
          </p: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463D95F0-7072-4C6E-8A57-06A9AD78B2D2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6031876" y="979601"/>
              <a:ext cx="1504874" cy="1988820"/>
              <a:chOff x="7125428" y="1856838"/>
              <a:chExt cx="2293186" cy="3017520"/>
            </a:xfrm>
          </p:grpSpPr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C648B218-C07A-436D-BA3C-DB39A9A545DD}"/>
                  </a:ext>
                </a:extLst>
              </p:cNvPr>
              <p:cNvPicPr preferRelativeResize="0">
                <a:picLocks/>
              </p:cNvPicPr>
              <p:nvPr/>
            </p:nvPicPr>
            <p:blipFill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7125428" y="1856838"/>
                <a:ext cx="2194560" cy="3017520"/>
              </a:xfrm>
              <a:prstGeom prst="rect">
                <a:avLst/>
              </a:prstGeom>
              <a:ln w="19050">
                <a:solidFill>
                  <a:schemeClr val="tx1"/>
                </a:solidFill>
              </a:ln>
            </p:spPr>
          </p:pic>
          <p:sp>
            <p:nvSpPr>
              <p:cNvPr id="13" name="TextBox 20">
                <a:extLst>
                  <a:ext uri="{FF2B5EF4-FFF2-40B4-BE49-F238E27FC236}">
                    <a16:creationId xmlns:a16="http://schemas.microsoft.com/office/drawing/2014/main" id="{90F71612-8D46-4513-9E76-B144340C2EDB}"/>
                  </a:ext>
                </a:extLst>
              </p:cNvPr>
              <p:cNvSpPr txBox="1"/>
              <p:nvPr/>
            </p:nvSpPr>
            <p:spPr>
              <a:xfrm>
                <a:off x="7822978" y="2464460"/>
                <a:ext cx="1595636" cy="66543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RAS G12D-NE</a:t>
                </a:r>
              </a:p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(preincubated with </a:t>
                </a:r>
              </a:p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1000nM BI-2852)</a:t>
                </a:r>
              </a:p>
            </p:txBody>
          </p:sp>
          <p:sp>
            <p:nvSpPr>
              <p:cNvPr id="14" name="TextBox 21">
                <a:extLst>
                  <a:ext uri="{FF2B5EF4-FFF2-40B4-BE49-F238E27FC236}">
                    <a16:creationId xmlns:a16="http://schemas.microsoft.com/office/drawing/2014/main" id="{12920245-7C9F-48AC-88F4-94765DCC73AB}"/>
                  </a:ext>
                </a:extLst>
              </p:cNvPr>
              <p:cNvSpPr txBox="1"/>
              <p:nvPr/>
            </p:nvSpPr>
            <p:spPr>
              <a:xfrm>
                <a:off x="8157006" y="4165432"/>
                <a:ext cx="1194979" cy="49031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RB-456</a:t>
                </a:r>
              </a:p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7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1C17F1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D = 2850nM</a:t>
                </a:r>
              </a:p>
            </p:txBody>
          </p:sp>
        </p:grpSp>
        <p:graphicFrame>
          <p:nvGraphicFramePr>
            <p:cNvPr id="22" name="Object 21">
              <a:extLst>
                <a:ext uri="{FF2B5EF4-FFF2-40B4-BE49-F238E27FC236}">
                  <a16:creationId xmlns:a16="http://schemas.microsoft.com/office/drawing/2014/main" id="{45800466-7727-48A7-BBE6-83953B86A258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1259760" y="4604188"/>
            <a:ext cx="1714500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8" name="Prism 9" r:id="rId7" imgW="3543015" imgH="2698634" progId="Prism9.Document">
                    <p:embed/>
                  </p:oleObj>
                </mc:Choice>
                <mc:Fallback>
                  <p:oleObj name="Prism 9" r:id="rId7" imgW="3543015" imgH="2698634" progId="Prism9.Document">
                    <p:embed/>
                    <p:pic>
                      <p:nvPicPr>
                        <p:cNvPr id="22" name="Object 21">
                          <a:extLst>
                            <a:ext uri="{FF2B5EF4-FFF2-40B4-BE49-F238E27FC236}">
                              <a16:creationId xmlns:a16="http://schemas.microsoft.com/office/drawing/2014/main" id="{45800466-7727-48A7-BBE6-83953B86A258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259760" y="4604188"/>
                          <a:ext cx="1714500" cy="1371600"/>
                        </a:xfrm>
                        <a:prstGeom prst="rect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23" name="Object 22">
              <a:extLst>
                <a:ext uri="{FF2B5EF4-FFF2-40B4-BE49-F238E27FC236}">
                  <a16:creationId xmlns:a16="http://schemas.microsoft.com/office/drawing/2014/main" id="{975EE5A8-AFBC-4FD5-8FA6-324A43BD690C}"/>
                </a:ext>
              </a:extLst>
            </p:cNvPr>
            <p:cNvGraphicFramePr>
              <a:graphicFrameLocks/>
            </p:cNvGraphicFramePr>
            <p:nvPr>
              <p:extLst/>
            </p:nvPr>
          </p:nvGraphicFramePr>
          <p:xfrm>
            <a:off x="1259760" y="3141257"/>
            <a:ext cx="1714500" cy="137160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29" name="Prism 9" r:id="rId9" imgW="3666542" imgH="2698634" progId="Prism9.Document">
                    <p:embed/>
                  </p:oleObj>
                </mc:Choice>
                <mc:Fallback>
                  <p:oleObj name="Prism 9" r:id="rId9" imgW="3666542" imgH="2698634" progId="Prism9.Document">
                    <p:embed/>
                    <p:pic>
                      <p:nvPicPr>
                        <p:cNvPr id="23" name="Object 22">
                          <a:extLst>
                            <a:ext uri="{FF2B5EF4-FFF2-40B4-BE49-F238E27FC236}">
                              <a16:creationId xmlns:a16="http://schemas.microsoft.com/office/drawing/2014/main" id="{975EE5A8-AFBC-4FD5-8FA6-324A43BD690C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1259760" y="3141257"/>
                          <a:ext cx="1714500" cy="1371600"/>
                        </a:xfrm>
                        <a:prstGeom prst="rect">
                          <a:avLst/>
                        </a:prstGeom>
                        <a:ln w="1905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pic>
          <p:nvPicPr>
            <p:cNvPr id="25" name="Picture 24" descr="A picture containing text, different, colorful&#10;&#10;Description automatically generated">
              <a:extLst>
                <a:ext uri="{FF2B5EF4-FFF2-40B4-BE49-F238E27FC236}">
                  <a16:creationId xmlns:a16="http://schemas.microsoft.com/office/drawing/2014/main" id="{6D60AF7F-51D3-471F-AC11-E1DE0B8C75E4}"/>
                </a:ext>
              </a:extLst>
            </p:cNvPr>
            <p:cNvPicPr preferRelativeResize="0"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3151015" y="3121760"/>
              <a:ext cx="4376238" cy="2880360"/>
            </a:xfrm>
            <a:prstGeom prst="rect">
              <a:avLst/>
            </a:prstGeom>
            <a:ln w="19050">
              <a:solidFill>
                <a:schemeClr val="tx1"/>
              </a:solidFill>
            </a:ln>
          </p:spPr>
        </p:pic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1FD8DA85-03FA-4538-815A-7AB1B4240249}"/>
                </a:ext>
              </a:extLst>
            </p:cNvPr>
            <p:cNvSpPr/>
            <p:nvPr/>
          </p:nvSpPr>
          <p:spPr>
            <a:xfrm>
              <a:off x="1097604" y="3105850"/>
              <a:ext cx="1946252" cy="2912183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6858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35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5CAA35A0-9656-4EFF-9947-BB314D33ACB8}"/>
                </a:ext>
              </a:extLst>
            </p:cNvPr>
            <p:cNvSpPr txBox="1"/>
            <p:nvPr/>
          </p:nvSpPr>
          <p:spPr>
            <a:xfrm>
              <a:off x="1045947" y="3108923"/>
              <a:ext cx="26642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6858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FDBDE696-EFC2-4C98-92C9-B6CF853C3084}"/>
                </a:ext>
              </a:extLst>
            </p:cNvPr>
            <p:cNvSpPr txBox="1"/>
            <p:nvPr/>
          </p:nvSpPr>
          <p:spPr>
            <a:xfrm>
              <a:off x="1033414" y="913842"/>
              <a:ext cx="260008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6858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3B3FA66-0B01-4A66-81C9-895F4C1EB134}"/>
                </a:ext>
              </a:extLst>
            </p:cNvPr>
            <p:cNvSpPr txBox="1"/>
            <p:nvPr/>
          </p:nvSpPr>
          <p:spPr>
            <a:xfrm>
              <a:off x="3112990" y="3096629"/>
              <a:ext cx="268841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6858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05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id="{11E8109B-2937-4762-A5C5-54074BFB7864}"/>
                </a:ext>
              </a:extLst>
            </p:cNvPr>
            <p:cNvSpPr/>
            <p:nvPr/>
          </p:nvSpPr>
          <p:spPr>
            <a:xfrm>
              <a:off x="1093474" y="919219"/>
              <a:ext cx="6433289" cy="2116397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6858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35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</p:grpSp>
      <p:sp>
        <p:nvSpPr>
          <p:cNvPr id="2" name="Rectangle 1">
            <a:extLst>
              <a:ext uri="{FF2B5EF4-FFF2-40B4-BE49-F238E27FC236}">
                <a16:creationId xmlns:a16="http://schemas.microsoft.com/office/drawing/2014/main" id="{A3B3C532-C14E-4E4D-BDA8-F1942068D335}"/>
              </a:ext>
            </a:extLst>
          </p:cNvPr>
          <p:cNvSpPr/>
          <p:nvPr/>
        </p:nvSpPr>
        <p:spPr>
          <a:xfrm>
            <a:off x="608683" y="240593"/>
            <a:ext cx="245291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ure S5: </a:t>
            </a:r>
            <a:endParaRPr kumimoji="0" lang="en-US" sz="3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031196198"/>
      </p:ext>
    </p:extLst>
  </p:cSld>
  <p:clrMapOvr>
    <a:masterClrMapping/>
  </p:clrMapOvr>
</p:sld>
</file>

<file path=ppt/theme/theme1.xml><?xml version="1.0" encoding="utf-8"?>
<a:theme xmlns:a="http://schemas.openxmlformats.org/drawingml/2006/main" name="3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4</Words>
  <Application>Microsoft Office PowerPoint</Application>
  <PresentationFormat>On-screen Show (4:3)</PresentationFormat>
  <Paragraphs>24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3_Office Theme</vt:lpstr>
      <vt:lpstr>Prism 9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id Sebti</dc:creator>
  <cp:lastModifiedBy>Said Sebti</cp:lastModifiedBy>
  <cp:revision>1</cp:revision>
  <dcterms:created xsi:type="dcterms:W3CDTF">2023-10-30T19:15:42Z</dcterms:created>
  <dcterms:modified xsi:type="dcterms:W3CDTF">2023-10-31T03:48:35Z</dcterms:modified>
</cp:coreProperties>
</file>